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9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4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817C9-294E-405B-88D6-31E76DCAAEDF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31513-D57E-4FA8-A3E4-47E9DBCC2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2793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817C9-294E-405B-88D6-31E76DCAAEDF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31513-D57E-4FA8-A3E4-47E9DBCC2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9830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817C9-294E-405B-88D6-31E76DCAAEDF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31513-D57E-4FA8-A3E4-47E9DBCC2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07459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817C9-294E-405B-88D6-31E76DCAAEDF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31513-D57E-4FA8-A3E4-47E9DBCC2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05001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817C9-294E-405B-88D6-31E76DCAAEDF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31513-D57E-4FA8-A3E4-47E9DBCC2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64146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817C9-294E-405B-88D6-31E76DCAAEDF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31513-D57E-4FA8-A3E4-47E9DBCC2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1517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817C9-294E-405B-88D6-31E76DCAAEDF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31513-D57E-4FA8-A3E4-47E9DBCC2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0513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817C9-294E-405B-88D6-31E76DCAAEDF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31513-D57E-4FA8-A3E4-47E9DBCC2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7435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817C9-294E-405B-88D6-31E76DCAAEDF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31513-D57E-4FA8-A3E4-47E9DBCC2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66721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817C9-294E-405B-88D6-31E76DCAAEDF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31513-D57E-4FA8-A3E4-47E9DBCC2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62760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817C9-294E-405B-88D6-31E76DCAAEDF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31513-D57E-4FA8-A3E4-47E9DBCC2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84455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B817C9-294E-405B-88D6-31E76DCAAEDF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631513-D57E-4FA8-A3E4-47E9DBCC2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1950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14700" y="2305050"/>
            <a:ext cx="5562600" cy="22479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314700" y="2510444"/>
            <a:ext cx="1180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/>
              <a:t>GII.4 VLP</a:t>
            </a:r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7088678" y="2782669"/>
            <a:ext cx="707245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/>
              <a:t>10 μ</a:t>
            </a:r>
            <a:r>
              <a:rPr lang="en-US"/>
              <a:t>g</a:t>
            </a:r>
            <a:r>
              <a:rPr lang="en-US" smtClean="0"/>
              <a:t/>
            </a:r>
            <a:br>
              <a:rPr lang="en-US" smtClean="0"/>
            </a:b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5978958" y="2782669"/>
            <a:ext cx="590226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5</a:t>
            </a:r>
            <a:r>
              <a:rPr lang="el-GR" dirty="0" smtClean="0"/>
              <a:t> </a:t>
            </a:r>
            <a:r>
              <a:rPr lang="el-GR" dirty="0"/>
              <a:t>μ</a:t>
            </a:r>
            <a:r>
              <a:rPr lang="en-US" dirty="0"/>
              <a:t>g</a:t>
            </a:r>
            <a:r>
              <a:rPr lang="en-US" dirty="0" smtClean="0"/>
              <a:t/>
            </a:r>
            <a:br>
              <a:rPr lang="en-US" dirty="0" smtClean="0"/>
            </a:br>
            <a:endParaRPr lang="en-US" dirty="0"/>
          </a:p>
        </p:txBody>
      </p:sp>
      <p:sp>
        <p:nvSpPr>
          <p:cNvPr id="9" name="Rectangle 8"/>
          <p:cNvSpPr/>
          <p:nvPr/>
        </p:nvSpPr>
        <p:spPr>
          <a:xfrm>
            <a:off x="4472079" y="2782669"/>
            <a:ext cx="764953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2.5</a:t>
            </a:r>
            <a:r>
              <a:rPr lang="el-GR" dirty="0" smtClean="0"/>
              <a:t> </a:t>
            </a:r>
            <a:r>
              <a:rPr lang="el-GR" dirty="0"/>
              <a:t>μ</a:t>
            </a:r>
            <a:r>
              <a:rPr lang="en-US" dirty="0"/>
              <a:t>g</a:t>
            </a:r>
            <a:r>
              <a:rPr lang="en-US" dirty="0" smtClean="0"/>
              <a:t/>
            </a:r>
            <a:br>
              <a:rPr lang="en-US" dirty="0" smtClean="0"/>
            </a:br>
            <a:endParaRPr lang="en-US" dirty="0"/>
          </a:p>
        </p:txBody>
      </p:sp>
      <p:sp>
        <p:nvSpPr>
          <p:cNvPr id="12" name="Rectangle 11"/>
          <p:cNvSpPr/>
          <p:nvPr/>
        </p:nvSpPr>
        <p:spPr>
          <a:xfrm>
            <a:off x="7088678" y="4032349"/>
            <a:ext cx="707245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/>
              <a:t>10 μ</a:t>
            </a:r>
            <a:r>
              <a:rPr lang="en-US"/>
              <a:t>g</a:t>
            </a:r>
            <a:r>
              <a:rPr lang="en-US" smtClean="0"/>
              <a:t/>
            </a:r>
            <a:br>
              <a:rPr lang="en-US" smtClean="0"/>
            </a:br>
            <a:endParaRPr lang="en-US" dirty="0"/>
          </a:p>
        </p:txBody>
      </p:sp>
      <p:sp>
        <p:nvSpPr>
          <p:cNvPr id="13" name="Rectangle 12"/>
          <p:cNvSpPr/>
          <p:nvPr/>
        </p:nvSpPr>
        <p:spPr>
          <a:xfrm>
            <a:off x="5978958" y="4032349"/>
            <a:ext cx="590226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5</a:t>
            </a:r>
            <a:r>
              <a:rPr lang="el-GR" dirty="0" smtClean="0"/>
              <a:t> </a:t>
            </a:r>
            <a:r>
              <a:rPr lang="el-GR" dirty="0"/>
              <a:t>μ</a:t>
            </a:r>
            <a:r>
              <a:rPr lang="en-US" dirty="0"/>
              <a:t>g</a:t>
            </a:r>
            <a:r>
              <a:rPr lang="en-US" dirty="0" smtClean="0"/>
              <a:t/>
            </a:r>
            <a:br>
              <a:rPr lang="en-US" dirty="0" smtClean="0"/>
            </a:br>
            <a:endParaRPr lang="en-US" dirty="0"/>
          </a:p>
        </p:txBody>
      </p:sp>
      <p:sp>
        <p:nvSpPr>
          <p:cNvPr id="14" name="Rectangle 13"/>
          <p:cNvSpPr/>
          <p:nvPr/>
        </p:nvSpPr>
        <p:spPr>
          <a:xfrm>
            <a:off x="8179555" y="4016400"/>
            <a:ext cx="707245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20</a:t>
            </a:r>
            <a:r>
              <a:rPr lang="el-GR" dirty="0" smtClean="0"/>
              <a:t> </a:t>
            </a:r>
            <a:r>
              <a:rPr lang="el-GR" dirty="0"/>
              <a:t>μ</a:t>
            </a:r>
            <a:r>
              <a:rPr lang="en-US" dirty="0"/>
              <a:t>g</a:t>
            </a:r>
            <a:r>
              <a:rPr lang="en-US" dirty="0" smtClean="0"/>
              <a:t/>
            </a:r>
            <a:br>
              <a:rPr lang="en-US" dirty="0" smtClean="0"/>
            </a:br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3314700" y="4181648"/>
            <a:ext cx="1981200" cy="3713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Jan 23 2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481667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/>
          <p:cNvSpPr txBox="1"/>
          <p:nvPr/>
        </p:nvSpPr>
        <p:spPr>
          <a:xfrm>
            <a:off x="10643062" y="6314903"/>
            <a:ext cx="1981200" cy="3713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Dec 12 2020</a:t>
            </a:r>
            <a:endParaRPr lang="en-US" dirty="0"/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2"/>
          <a:srcRect t="25727" b="13371"/>
          <a:stretch/>
        </p:blipFill>
        <p:spPr>
          <a:xfrm flipH="1">
            <a:off x="5005797" y="711547"/>
            <a:ext cx="2419350" cy="2384181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4829520" y="275916"/>
            <a:ext cx="3449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ure 3g and 4e</a:t>
            </a:r>
            <a:endParaRPr lang="en-US" dirty="0"/>
          </a:p>
        </p:txBody>
      </p:sp>
      <p:sp>
        <p:nvSpPr>
          <p:cNvPr id="23" name="TextBox 22"/>
          <p:cNvSpPr txBox="1"/>
          <p:nvPr/>
        </p:nvSpPr>
        <p:spPr>
          <a:xfrm>
            <a:off x="7336762" y="681639"/>
            <a:ext cx="670560" cy="36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160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7336762" y="941391"/>
            <a:ext cx="670560" cy="36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125</a:t>
            </a:r>
            <a:endParaRPr lang="en-US" dirty="0"/>
          </a:p>
        </p:txBody>
      </p:sp>
      <p:sp>
        <p:nvSpPr>
          <p:cNvPr id="25" name="TextBox 24"/>
          <p:cNvSpPr txBox="1"/>
          <p:nvPr/>
        </p:nvSpPr>
        <p:spPr>
          <a:xfrm>
            <a:off x="7336762" y="1248306"/>
            <a:ext cx="670560" cy="36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90</a:t>
            </a:r>
            <a:endParaRPr lang="en-US" dirty="0"/>
          </a:p>
        </p:txBody>
      </p:sp>
      <p:sp>
        <p:nvSpPr>
          <p:cNvPr id="26" name="TextBox 25"/>
          <p:cNvSpPr txBox="1"/>
          <p:nvPr/>
        </p:nvSpPr>
        <p:spPr>
          <a:xfrm>
            <a:off x="7336762" y="1850980"/>
            <a:ext cx="670560" cy="36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50</a:t>
            </a:r>
            <a:endParaRPr lang="en-US" dirty="0"/>
          </a:p>
        </p:txBody>
      </p:sp>
      <p:grpSp>
        <p:nvGrpSpPr>
          <p:cNvPr id="35" name="Group 34"/>
          <p:cNvGrpSpPr/>
          <p:nvPr/>
        </p:nvGrpSpPr>
        <p:grpSpPr>
          <a:xfrm>
            <a:off x="1140153" y="3357721"/>
            <a:ext cx="3832623" cy="3070206"/>
            <a:chOff x="988931" y="3568951"/>
            <a:chExt cx="3832623" cy="3070206"/>
          </a:xfrm>
        </p:grpSpPr>
        <p:grpSp>
          <p:nvGrpSpPr>
            <p:cNvPr id="28" name="Group 27"/>
            <p:cNvGrpSpPr/>
            <p:nvPr/>
          </p:nvGrpSpPr>
          <p:grpSpPr>
            <a:xfrm>
              <a:off x="988931" y="3568951"/>
              <a:ext cx="3832623" cy="2928832"/>
              <a:chOff x="1246712" y="3186567"/>
              <a:chExt cx="3832623" cy="2928832"/>
            </a:xfrm>
          </p:grpSpPr>
          <p:sp>
            <p:nvSpPr>
              <p:cNvPr id="5" name="TextBox 4"/>
              <p:cNvSpPr txBox="1"/>
              <p:nvPr/>
            </p:nvSpPr>
            <p:spPr>
              <a:xfrm>
                <a:off x="1363614" y="4274551"/>
                <a:ext cx="670560" cy="3657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err="1" smtClean="0"/>
                  <a:t>Villin</a:t>
                </a:r>
                <a:endParaRPr lang="en-US" dirty="0"/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4408775" y="3935555"/>
                <a:ext cx="670560" cy="3657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160</a:t>
                </a:r>
                <a:endParaRPr lang="en-US" dirty="0"/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4408775" y="4162384"/>
                <a:ext cx="670560" cy="3657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125</a:t>
                </a:r>
                <a:endParaRPr lang="en-US" dirty="0"/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4408775" y="4498091"/>
                <a:ext cx="670560" cy="3657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90</a:t>
                </a:r>
                <a:endParaRPr lang="en-US" dirty="0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4408775" y="5083372"/>
                <a:ext cx="670560" cy="3657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50</a:t>
                </a:r>
                <a:endParaRPr lang="en-US" dirty="0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4408775" y="5749639"/>
                <a:ext cx="670560" cy="3657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25</a:t>
                </a:r>
                <a:endParaRPr lang="en-US" dirty="0"/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1246712" y="5264466"/>
                <a:ext cx="98661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GAPDH</a:t>
                </a:r>
                <a:endParaRPr lang="en-US" dirty="0"/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1350948" y="5523592"/>
                <a:ext cx="98661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mtClean="0"/>
                  <a:t>Gal-3</a:t>
                </a:r>
                <a:endParaRPr lang="en-US" dirty="0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2452341" y="3678148"/>
                <a:ext cx="98661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BSP</a:t>
                </a:r>
                <a:endParaRPr lang="en-US" dirty="0"/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3019035" y="3678148"/>
                <a:ext cx="98661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err="1" smtClean="0"/>
                  <a:t>Cyto</a:t>
                </a:r>
                <a:endParaRPr lang="en-US" dirty="0"/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2056340" y="3186567"/>
                <a:ext cx="267946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Supplementary Figure 3g</a:t>
                </a:r>
                <a:endParaRPr lang="en-US" dirty="0"/>
              </a:p>
            </p:txBody>
          </p:sp>
        </p:grpSp>
        <p:pic>
          <p:nvPicPr>
            <p:cNvPr id="31" name="Picture 30"/>
            <p:cNvPicPr>
              <a:picLocks noChangeAspect="1"/>
            </p:cNvPicPr>
            <p:nvPr/>
          </p:nvPicPr>
          <p:blipFill rotWithShape="1">
            <a:blip r:embed="rId3"/>
            <a:srcRect l="688" t="26112" r="-688" b="15919"/>
            <a:stretch/>
          </p:blipFill>
          <p:spPr>
            <a:xfrm flipH="1">
              <a:off x="1739610" y="4369782"/>
              <a:ext cx="2419350" cy="2269375"/>
            </a:xfrm>
            <a:prstGeom prst="rect">
              <a:avLst/>
            </a:prstGeom>
          </p:spPr>
        </p:pic>
      </p:grpSp>
      <p:grpSp>
        <p:nvGrpSpPr>
          <p:cNvPr id="38" name="Group 37"/>
          <p:cNvGrpSpPr/>
          <p:nvPr/>
        </p:nvGrpSpPr>
        <p:grpSpPr>
          <a:xfrm>
            <a:off x="7336762" y="2405361"/>
            <a:ext cx="3872193" cy="3970298"/>
            <a:chOff x="7336762" y="2405361"/>
            <a:chExt cx="3872193" cy="3970298"/>
          </a:xfrm>
        </p:grpSpPr>
        <p:sp>
          <p:nvSpPr>
            <p:cNvPr id="27" name="TextBox 26"/>
            <p:cNvSpPr txBox="1"/>
            <p:nvPr/>
          </p:nvSpPr>
          <p:spPr>
            <a:xfrm>
              <a:off x="7336762" y="2405361"/>
              <a:ext cx="670560" cy="3657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25</a:t>
              </a:r>
              <a:endParaRPr lang="en-US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7968703" y="3271027"/>
              <a:ext cx="267946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Supplementary Figure 4e</a:t>
              </a:r>
              <a:endParaRPr lang="en-US" dirty="0"/>
            </a:p>
          </p:txBody>
        </p:sp>
        <p:pic>
          <p:nvPicPr>
            <p:cNvPr id="30" name="Picture 29"/>
            <p:cNvPicPr>
              <a:picLocks noChangeAspect="1"/>
            </p:cNvPicPr>
            <p:nvPr/>
          </p:nvPicPr>
          <p:blipFill rotWithShape="1">
            <a:blip r:embed="rId4"/>
            <a:srcRect t="27701" b="11731"/>
            <a:stretch/>
          </p:blipFill>
          <p:spPr>
            <a:xfrm flipH="1">
              <a:off x="8098762" y="4004582"/>
              <a:ext cx="2419350" cy="2371077"/>
            </a:xfrm>
            <a:prstGeom prst="rect">
              <a:avLst/>
            </a:prstGeom>
          </p:spPr>
        </p:pic>
        <p:sp>
          <p:nvSpPr>
            <p:cNvPr id="32" name="TextBox 31"/>
            <p:cNvSpPr txBox="1"/>
            <p:nvPr/>
          </p:nvSpPr>
          <p:spPr>
            <a:xfrm>
              <a:off x="10518112" y="4078436"/>
              <a:ext cx="670560" cy="3657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125</a:t>
              </a:r>
              <a:endParaRPr lang="en-US" dirty="0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10538395" y="4709944"/>
              <a:ext cx="670560" cy="3657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70</a:t>
              </a:r>
              <a:endParaRPr lang="en-US" dirty="0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7532068" y="4207245"/>
              <a:ext cx="670560" cy="3657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ALIX</a:t>
              </a:r>
              <a:endParaRPr lang="en-US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8523424" y="3709104"/>
              <a:ext cx="98661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BSP</a:t>
              </a:r>
              <a:endParaRPr lang="en-US" dirty="0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9090118" y="3709104"/>
              <a:ext cx="98661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 smtClean="0"/>
                <a:t>Cyto</a:t>
              </a:r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5557304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0643062" y="6314903"/>
            <a:ext cx="1981200" cy="3713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ay 25 2021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/>
          <a:srcRect b="22822"/>
          <a:stretch/>
        </p:blipFill>
        <p:spPr>
          <a:xfrm>
            <a:off x="4419600" y="1509712"/>
            <a:ext cx="3352800" cy="296253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4419600" y="2435630"/>
            <a:ext cx="670560" cy="36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250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419600" y="2901142"/>
            <a:ext cx="670560" cy="36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150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419600" y="3183774"/>
            <a:ext cx="670560" cy="36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100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461164" y="3523941"/>
            <a:ext cx="670560" cy="36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75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7813964" y="3084022"/>
            <a:ext cx="670560" cy="36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rgbClr val="00B050"/>
                </a:solidFill>
              </a:rPr>
              <a:t>ALIX</a:t>
            </a:r>
            <a:endParaRPr lang="en-US" dirty="0">
              <a:solidFill>
                <a:srgbClr val="00B050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813964" y="3361548"/>
            <a:ext cx="670560" cy="36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>
                <a:solidFill>
                  <a:srgbClr val="FF0000"/>
                </a:solidFill>
              </a:rPr>
              <a:t>Villin</a:t>
            </a:r>
            <a:endParaRPr lang="en-US" dirty="0">
              <a:solidFill>
                <a:srgbClr val="FF0000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481946" y="3806573"/>
            <a:ext cx="670560" cy="36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50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920837" y="855778"/>
            <a:ext cx="26794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ure 4j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655513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</TotalTime>
  <Words>76</Words>
  <Application>Microsoft Office PowerPoint</Application>
  <PresentationFormat>Widescreen</PresentationFormat>
  <Paragraphs>4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>Baylor College of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yyar, B Vijayalakshmi</dc:creator>
  <cp:lastModifiedBy>Ayyar, B Vijayalakshmi</cp:lastModifiedBy>
  <cp:revision>7</cp:revision>
  <dcterms:created xsi:type="dcterms:W3CDTF">2022-12-20T19:22:07Z</dcterms:created>
  <dcterms:modified xsi:type="dcterms:W3CDTF">2022-12-20T21:25:09Z</dcterms:modified>
</cp:coreProperties>
</file>